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152" y="1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8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组合 18"/>
          <p:cNvGrpSpPr/>
          <p:nvPr/>
        </p:nvGrpSpPr>
        <p:grpSpPr>
          <a:xfrm>
            <a:off x="-688009" y="980728"/>
            <a:ext cx="10516593" cy="4478486"/>
            <a:chOff x="-688009" y="980728"/>
            <a:chExt cx="10516593" cy="4478486"/>
          </a:xfrm>
        </p:grpSpPr>
        <p:graphicFrame>
          <p:nvGraphicFramePr>
            <p:cNvPr id="10" name="对象 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23350133"/>
                </p:ext>
              </p:extLst>
            </p:nvPr>
          </p:nvGraphicFramePr>
          <p:xfrm>
            <a:off x="-676175" y="980728"/>
            <a:ext cx="6013803" cy="447115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3" name="Graph" r:id="rId3" imgW="4161600" imgH="2907360" progId="Origin50.Graph">
                    <p:embed/>
                  </p:oleObj>
                </mc:Choice>
                <mc:Fallback>
                  <p:oleObj name="Graph" r:id="rId3" imgW="4161600" imgH="2907360" progId="Origin50.Graph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-676175" y="980728"/>
                          <a:ext cx="6013803" cy="447115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对象 1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25118152"/>
                </p:ext>
              </p:extLst>
            </p:nvPr>
          </p:nvGraphicFramePr>
          <p:xfrm>
            <a:off x="-688009" y="988055"/>
            <a:ext cx="6027571" cy="447115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4" name="Graph" r:id="rId5" imgW="4170240" imgH="2907360" progId="Origin50.Graph">
                    <p:embed/>
                  </p:oleObj>
                </mc:Choice>
                <mc:Fallback>
                  <p:oleObj name="Graph" r:id="rId5" imgW="4170240" imgH="2907360" progId="Origin50.Graph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-688009" y="988055"/>
                          <a:ext cx="6027571" cy="447115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对象 1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29218013"/>
                </p:ext>
              </p:extLst>
            </p:nvPr>
          </p:nvGraphicFramePr>
          <p:xfrm>
            <a:off x="3801013" y="980728"/>
            <a:ext cx="6027571" cy="447115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5" name="Graph" r:id="rId7" imgW="4170240" imgH="2907360" progId="Origin50.Graph">
                    <p:embed/>
                  </p:oleObj>
                </mc:Choice>
                <mc:Fallback>
                  <p:oleObj name="Graph" r:id="rId7" imgW="4170240" imgH="2907360" progId="Origin50.Graph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801013" y="980728"/>
                          <a:ext cx="6027571" cy="447115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3" name="对象 1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11281037"/>
                </p:ext>
              </p:extLst>
            </p:nvPr>
          </p:nvGraphicFramePr>
          <p:xfrm>
            <a:off x="3801013" y="980728"/>
            <a:ext cx="6027571" cy="447115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6" name="Graph" r:id="rId9" imgW="4170240" imgH="2907360" progId="Origin50.Graph">
                    <p:embed/>
                  </p:oleObj>
                </mc:Choice>
                <mc:Fallback>
                  <p:oleObj name="Graph" r:id="rId9" imgW="4170240" imgH="2907360" progId="Origin50.Graph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801013" y="980728"/>
                          <a:ext cx="6027571" cy="447115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5" name="TextBox 14"/>
          <p:cNvSpPr txBox="1"/>
          <p:nvPr/>
        </p:nvSpPr>
        <p:spPr>
          <a:xfrm rot="16200000">
            <a:off x="3994979" y="3066492"/>
            <a:ext cx="12647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Transmittance (%)</a:t>
            </a:r>
            <a:endParaRPr lang="zh-CN" altLang="en-US" sz="110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-494917" y="3041092"/>
            <a:ext cx="12647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Transmittance (%)</a:t>
            </a:r>
            <a:endParaRPr lang="zh-CN" altLang="en-US" sz="1100" dirty="0"/>
          </a:p>
        </p:txBody>
      </p:sp>
      <p:sp>
        <p:nvSpPr>
          <p:cNvPr id="17" name="TextBox 16"/>
          <p:cNvSpPr txBox="1"/>
          <p:nvPr/>
        </p:nvSpPr>
        <p:spPr>
          <a:xfrm>
            <a:off x="1619672" y="4882371"/>
            <a:ext cx="13681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Wavenumber (cm</a:t>
            </a:r>
            <a:r>
              <a:rPr lang="en-US" altLang="zh-CN" sz="1100" baseline="30000" dirty="0" smtClean="0"/>
              <a:t>-1</a:t>
            </a:r>
            <a:r>
              <a:rPr lang="en-US" altLang="zh-CN" sz="1100" dirty="0" smtClean="0"/>
              <a:t>)</a:t>
            </a:r>
            <a:endParaRPr lang="zh-CN" altLang="en-US" sz="1100" dirty="0"/>
          </a:p>
        </p:txBody>
      </p:sp>
      <p:sp>
        <p:nvSpPr>
          <p:cNvPr id="18" name="TextBox 17"/>
          <p:cNvSpPr txBox="1"/>
          <p:nvPr/>
        </p:nvSpPr>
        <p:spPr>
          <a:xfrm>
            <a:off x="6300192" y="4895582"/>
            <a:ext cx="13681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Wavenumber (cm</a:t>
            </a:r>
            <a:r>
              <a:rPr lang="en-US" altLang="zh-CN" sz="1100" baseline="30000" dirty="0" smtClean="0"/>
              <a:t>-1</a:t>
            </a:r>
            <a:r>
              <a:rPr lang="en-US" altLang="zh-CN" sz="1100" dirty="0" smtClean="0"/>
              <a:t>)</a:t>
            </a:r>
            <a:endParaRPr lang="zh-CN" altLang="en-US" sz="1100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2550083" y="3814442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620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746173" y="4023993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379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3145197" y="4177534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37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3361221" y="3673478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97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3463427" y="3686956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78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16200000">
            <a:off x="3717550" y="4124337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75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727123" y="2146213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377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2569133" y="1945287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622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 rot="16200000">
            <a:off x="3145197" y="2650269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30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 rot="16200000">
            <a:off x="2781446" y="1873279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84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6200000">
            <a:off x="3463426" y="1786173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78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 rot="16200000">
            <a:off x="3361221" y="1786173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97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 rot="16200000">
            <a:off x="3721260" y="2112162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75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 rot="16200000">
            <a:off x="5191618" y="3961511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420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 rot="16200000">
            <a:off x="7033629" y="3601471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634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 rot="16200000">
            <a:off x="7586932" y="3879978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94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 rot="16200000">
            <a:off x="8215954" y="3639570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72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 rot="16200000">
            <a:off x="5191618" y="2568975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397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 rot="16200000">
            <a:off x="7020393" y="2022627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631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 rot="16200000">
            <a:off x="7653126" y="2521351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30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 rot="16200000">
            <a:off x="7904680" y="1821461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79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 rot="16200000">
            <a:off x="7999930" y="1873278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94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 rot="16200000">
            <a:off x="8215954" y="2214650"/>
            <a:ext cx="591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75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789723" y="1518186"/>
            <a:ext cx="1406013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SBC</a:t>
            </a:r>
            <a:r>
              <a:rPr lang="zh-CN" altLang="en-US" sz="1100" dirty="0" smtClean="0"/>
              <a:t> </a:t>
            </a:r>
            <a:r>
              <a:rPr lang="en-US" altLang="zh-CN" sz="1100" dirty="0" smtClean="0"/>
              <a:t>after adsorption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793676" y="3167390"/>
            <a:ext cx="1514025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SBC</a:t>
            </a:r>
            <a:r>
              <a:rPr lang="zh-CN" altLang="en-US" sz="1100" dirty="0" smtClean="0"/>
              <a:t> </a:t>
            </a:r>
            <a:r>
              <a:rPr lang="en-US" altLang="zh-CN" sz="1100" dirty="0" smtClean="0"/>
              <a:t>before adsorption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5290223" y="1518186"/>
            <a:ext cx="1658041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MSBC</a:t>
            </a:r>
            <a:r>
              <a:rPr lang="zh-CN" altLang="en-US" sz="1100" dirty="0" smtClean="0"/>
              <a:t> </a:t>
            </a:r>
            <a:r>
              <a:rPr lang="en-US" altLang="zh-CN" sz="1100" dirty="0" smtClean="0"/>
              <a:t>after adsorption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5290223" y="3140968"/>
            <a:ext cx="1658041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MSBC</a:t>
            </a:r>
            <a:r>
              <a:rPr lang="zh-CN" altLang="en-US" sz="1100" dirty="0" smtClean="0"/>
              <a:t> </a:t>
            </a:r>
            <a:r>
              <a:rPr lang="en-US" altLang="zh-CN" sz="1100" dirty="0" smtClean="0"/>
              <a:t>before adsorption</a:t>
            </a:r>
          </a:p>
        </p:txBody>
      </p:sp>
    </p:spTree>
    <p:extLst>
      <p:ext uri="{BB962C8B-B14F-4D97-AF65-F5344CB8AC3E}">
        <p14:creationId xmlns:p14="http://schemas.microsoft.com/office/powerpoint/2010/main" val="38220575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47</Words>
  <Application>Microsoft Office PowerPoint</Application>
  <PresentationFormat>全屏显示(4:3)</PresentationFormat>
  <Paragraphs>31</Paragraphs>
  <Slides>1</Slides>
  <Notes>0</Notes>
  <HiddenSlides>0</HiddenSlides>
  <MMClips>0</MMClips>
  <ScaleCrop>false</ScaleCrop>
  <HeadingPairs>
    <vt:vector size="6" baseType="variant"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3" baseType="lpstr">
      <vt:lpstr>Office 主题</vt:lpstr>
      <vt:lpstr>Origin Graph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HUT-Leslie</dc:creator>
  <cp:lastModifiedBy>WHUT-Leslie</cp:lastModifiedBy>
  <cp:revision>6</cp:revision>
  <dcterms:modified xsi:type="dcterms:W3CDTF">2018-10-21T07:17:43Z</dcterms:modified>
</cp:coreProperties>
</file>